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9" d="100"/>
          <a:sy n="119" d="100"/>
        </p:scale>
        <p:origin x="15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83F618-8F57-4401-AE84-85084DA29F42}" type="datetimeFigureOut">
              <a:rPr lang="de-DE" smtClean="0"/>
              <a:t>20.10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08D96C-9DAE-46FC-BA1B-6E560FC868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0993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090BCA-D588-4662-9861-A13D38080E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593C6F9-F808-43CC-850F-D5442628EF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B416954-1C63-4855-AD49-5485E46E2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E894C-9992-4EA4-A74C-CCD9F346E738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48D23F1-8AE5-497F-9056-C376E3E2A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DFC87E8-1BDD-426D-BE90-3CC8CD006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4227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0FE3D8-148B-4F7C-B80B-99C8B7F64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E7DACC6-2C85-4A9F-8EDC-0EFE0E211B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3B0871D-DAE0-42FF-BDC2-348ED19B0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42888-10FF-4814-B755-EE523C652488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504E824-A7B8-4AF7-9E16-DEBC10107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56F9921-C532-40D4-A0C7-D67534F3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423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75CFD77-5F28-4106-A1EE-87665E9F45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A5D6ED5-D1F8-47D1-B809-FBA6EA75B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D10F849-2ECF-4159-A70B-B7E7640E7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41F30-01E9-4CB7-9C16-D5831A1069A9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9A4337-FCBA-4D23-857E-C09C68546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283A15A-4EEC-4CF7-8FD0-1928BF835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1462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5D505B-9847-4AA9-82C9-D36DF92CFB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E1B4C1F-4599-41DB-BD46-30F66DA59C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007A4BF-1A3E-442A-A026-8B85BF5DE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E945D-655D-4378-A8B1-72B1528587EC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B41E56A-9C29-4CBE-A762-F1A904074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E6CBA59-1709-4FAE-A2A7-E095F1D70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9467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38D4AA0-13E3-4511-8D6D-985AA5077B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561CC5E-AC96-460B-BE47-10CFC9256C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846CC67-072F-448E-B7E2-6348BE3C3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CFCA9-72A2-4B8D-9267-68772C1FEC0C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554024-FDA9-40B1-8706-0FA7FA7D0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6FEE32C-4373-42F6-848B-54E7C4300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7944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E57A712-F8D8-4F9D-ACCC-3E7420CCC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03F2112-C57E-4FED-8132-EB05C35A62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C33773C-403C-46B1-AD20-CFD3650E5E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A69443F-409C-42A2-B399-EA047A78A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E7E9C5-EE16-4E0C-A295-467EA68DB1AC}" type="datetime1">
              <a:rPr lang="de-DE" smtClean="0"/>
              <a:t>20.10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E4222F5-28F2-4AE9-8B69-149862FD0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680DD16-0098-4668-8C58-219DE4A99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8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2C5054-EC8A-4403-A7B7-AD769F9CA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0FC132B-7917-405C-9593-7E48E5F2F4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EE26B65-702D-40BA-BFA6-DA1975A6B6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E79C09B-FFD7-4EBA-BDCD-BE4FE84AAC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BB70E2F-08C4-4ECF-868C-4506216C7F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1C39E3F-18EC-46D1-AA3B-03A4F4A28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009898-0E68-496C-86D6-5D2D30FCEB4F}" type="datetime1">
              <a:rPr lang="de-DE" smtClean="0"/>
              <a:t>20.10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8E9A5D0B-188E-4B9C-ABE8-4234CA9F3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E99BD43-0B4D-4830-B0DD-BC2D14C42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551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3BAA23-F745-46A5-A757-47D557740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6980F178-E6E8-4CC0-8A55-993AC214E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B2180-A8D4-44B7-87CF-AD21A3CA5D03}" type="datetime1">
              <a:rPr lang="de-DE" smtClean="0"/>
              <a:t>20.10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82B611A-0D69-476D-B99B-064214B00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B52C4E45-F15E-464B-8971-7AC7F5E4C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014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A52BF6E-B089-4189-8BFC-C1AC8807A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65C0B-B391-4D7D-A1FD-B8C3DA59F79F}" type="datetime1">
              <a:rPr lang="de-DE" smtClean="0"/>
              <a:t>20.10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A5AD8B7-C3D9-4F22-A7E0-ADE791D59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7C1DE8B-0EEA-4407-B979-3B98EA661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4108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B57292-201F-4F16-8111-6C062FD11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D988BB5-DB3B-456D-9168-CF96941D9D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D2A7E6D-E960-4941-A6A6-2A20764000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9DE5ED0-F1D2-4502-A52A-E5AF8425C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45B61-647D-44A8-B3EB-2B19B00D47EC}" type="datetime1">
              <a:rPr lang="de-DE" smtClean="0"/>
              <a:t>20.10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9ECC22D-9A32-4A6B-97D0-B29DF657B9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182CB2A-A3E5-4C31-8535-6A2494717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5197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74F627-1E09-4EDB-9864-1610D5C55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5A0EA25-A25A-4F22-83A0-F94EC7680D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47140A4-D947-4770-86F0-DB97226EBF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62F757B-6AA2-406C-8E6A-2FF28DD29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92F8D-DEFF-4277-97D6-1A8CD09B25C7}" type="datetime1">
              <a:rPr lang="de-DE" smtClean="0"/>
              <a:t>20.10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BE1767A-05F2-4B9C-859F-991F2B7FC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47FB57A-015A-4EBF-9FB2-59F353F7B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123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7359D37-70CE-43D9-9758-EE3784A91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7237EA1-63D4-4A85-BF37-F28DDC85F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187A5B3-C40A-4E45-A739-D45EE69673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9CB3A-EF9A-4F4D-A711-123EE126BD7B}" type="datetime1">
              <a:rPr lang="de-DE" smtClean="0"/>
              <a:t>20.10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05347C1-D48B-4749-BE4D-AB4AB314CC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/>
              <a:t>(c) Joachim Paier (HU Berlin, 20.10.2020)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FDF674-E2E8-41CE-ACC7-4DCE3F8C3F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2DB7D-3CC0-4E37-B7E2-C9B1404EF52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514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Ein Bild, das farbig enthält.&#10;&#10;Automatisch generierte Beschreibung">
            <a:extLst>
              <a:ext uri="{FF2B5EF4-FFF2-40B4-BE49-F238E27FC236}">
                <a16:creationId xmlns:a16="http://schemas.microsoft.com/office/drawing/2014/main" id="{4BCB9000-56D6-4D1E-AB05-F7640AED2C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100" y="990600"/>
            <a:ext cx="7543800" cy="48768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A1B38B7-7489-4AAB-9D57-4209483B7172}"/>
              </a:ext>
            </a:extLst>
          </p:cNvPr>
          <p:cNvSpPr txBox="1"/>
          <p:nvPr/>
        </p:nvSpPr>
        <p:spPr>
          <a:xfrm>
            <a:off x="489284" y="200526"/>
            <a:ext cx="3529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MLFF-MD Training </a:t>
            </a:r>
            <a:r>
              <a:rPr lang="de-DE" dirty="0" err="1"/>
              <a:t>for</a:t>
            </a:r>
            <a:r>
              <a:rPr lang="de-DE" dirty="0"/>
              <a:t> MgO Clusters</a:t>
            </a:r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CB9D4AF-2DA9-43E9-9027-734B2A550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</p:spTree>
    <p:extLst>
      <p:ext uri="{BB962C8B-B14F-4D97-AF65-F5344CB8AC3E}">
        <p14:creationId xmlns:p14="http://schemas.microsoft.com/office/powerpoint/2010/main" val="3124617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13204F01-6D2A-476B-A321-E8CA391627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9450" y="1200150"/>
            <a:ext cx="5753100" cy="445770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14E98F69-893B-4351-952D-04EC265B4B41}"/>
              </a:ext>
            </a:extLst>
          </p:cNvPr>
          <p:cNvSpPr txBox="1"/>
          <p:nvPr/>
        </p:nvSpPr>
        <p:spPr>
          <a:xfrm>
            <a:off x="489284" y="200526"/>
            <a:ext cx="35292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MLFF-MD Training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FeOx</a:t>
            </a:r>
            <a:r>
              <a:rPr lang="de-DE"/>
              <a:t> Systems</a:t>
            </a:r>
            <a:endParaRPr lang="de-DE" dirty="0"/>
          </a:p>
        </p:txBody>
      </p:sp>
      <p:sp>
        <p:nvSpPr>
          <p:cNvPr id="7" name="Fußzeilenplatzhalter 6">
            <a:extLst>
              <a:ext uri="{FF2B5EF4-FFF2-40B4-BE49-F238E27FC236}">
                <a16:creationId xmlns:a16="http://schemas.microsoft.com/office/drawing/2014/main" id="{B64D1B42-E1EF-443E-A7BF-5B0D2C51C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(c) Joachim Paier (HU Berlin, 20.10.2020)</a:t>
            </a:r>
          </a:p>
        </p:txBody>
      </p:sp>
    </p:spTree>
    <p:extLst>
      <p:ext uri="{BB962C8B-B14F-4D97-AF65-F5344CB8AC3E}">
        <p14:creationId xmlns:p14="http://schemas.microsoft.com/office/powerpoint/2010/main" val="3456383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reitbild</PresentationFormat>
  <Paragraphs>4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achim Paier</dc:creator>
  <cp:lastModifiedBy>Joachim Paier</cp:lastModifiedBy>
  <cp:revision>3</cp:revision>
  <dcterms:created xsi:type="dcterms:W3CDTF">2020-10-20T14:14:28Z</dcterms:created>
  <dcterms:modified xsi:type="dcterms:W3CDTF">2020-10-20T14:16:37Z</dcterms:modified>
</cp:coreProperties>
</file>